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3729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0825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1929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144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9725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2610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7128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4892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4945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055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891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8044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490832" y="2029562"/>
            <a:ext cx="713695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able S1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PCR Primer Sequences for Cell Type-Fibroblast Markers (All 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anis lupus </a:t>
            </a:r>
            <a:r>
              <a:rPr kumimoji="0" lang="en-US" altLang="ko-KR" sz="12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amiliaris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</a:t>
            </a:r>
            <a:endParaRPr kumimoji="0" lang="en-US" altLang="ko-KR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1025" name="그림 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3344" y="2445061"/>
            <a:ext cx="5734050" cy="2257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838200" y="496693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5024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7</TotalTime>
  <Words>1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DS</dc:creator>
  <cp:lastModifiedBy>MDPI</cp:lastModifiedBy>
  <cp:revision>31</cp:revision>
  <cp:lastPrinted>2019-03-21T10:20:30Z</cp:lastPrinted>
  <dcterms:created xsi:type="dcterms:W3CDTF">2019-03-03T02:45:14Z</dcterms:created>
  <dcterms:modified xsi:type="dcterms:W3CDTF">2021-08-04T10:35:04Z</dcterms:modified>
</cp:coreProperties>
</file>